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6803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2450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2003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4182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2291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4323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8538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6705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2816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3221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370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65DF23-C408-4CC0-86FF-2BA8E553C958}" type="datetimeFigureOut">
              <a:rPr lang="de-DE" smtClean="0"/>
              <a:t>2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449C8-0884-4F16-A17D-24C5D60361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1132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91886" y="501171"/>
            <a:ext cx="93306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2 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letion of the </a:t>
            </a:r>
            <a:r>
              <a:rPr lang="en-US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E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A0U90_11950)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chanism is given in (A) displayed with the particular basic vector pKos6b. The deletion of the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A0U90_11950) is shown in (B). The upstream and downstream fragment of the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are shown as grey bars.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US" sz="10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anamycin resistance cassette,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dA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ytosine deaminase gene of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cherichia (E.) coli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dB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ytosine permease gene of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.,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s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uridin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,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tsK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ell division protein. (C) Agarose gel of colony PCR verifying the deletion of the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n the genome; lane 1 showing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. baliensi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BRC 16680 R with the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300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ane 2 showing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. baliensi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BRC 16680 R with a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letion (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pol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with a PCR product of 195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.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Grafik 5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382" y="1516834"/>
            <a:ext cx="6119495" cy="499999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91376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6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k</dc:creator>
  <cp:lastModifiedBy>Frank</cp:lastModifiedBy>
  <cp:revision>1</cp:revision>
  <dcterms:created xsi:type="dcterms:W3CDTF">2017-04-20T14:17:06Z</dcterms:created>
  <dcterms:modified xsi:type="dcterms:W3CDTF">2017-04-20T14:17:18Z</dcterms:modified>
</cp:coreProperties>
</file>